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0" r:id="rId2"/>
    <p:sldId id="262" r:id="rId3"/>
    <p:sldId id="269" r:id="rId4"/>
    <p:sldId id="282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6357" autoAdjust="0"/>
  </p:normalViewPr>
  <p:slideViewPr>
    <p:cSldViewPr snapToGrid="0">
      <p:cViewPr varScale="1">
        <p:scale>
          <a:sx n="88" d="100"/>
          <a:sy n="88" d="100"/>
        </p:scale>
        <p:origin x="90" y="6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CE9EEB-B073-4A8D-88E3-EB282089DD0F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2BC3F0-2B9A-4ABE-84C1-2EE2BE0864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51890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1.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artitioned genetic correlation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tween BF% and HF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y genetic variants groups with different P value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5C1AF2-2721-4E98-B944-E16C54751995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466529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2.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artitioned genetic correlation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etween BF% and CAD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y genetic variants groups with different P value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5C1AF2-2721-4E98-B944-E16C54751995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370392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3.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QQ plot of cross-trait meta-analysis between BF% and HF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5C1AF2-2721-4E98-B944-E16C54751995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239291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4.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QQ plot of cross-trait meta-analysis between BF% and CAD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5C1AF2-2721-4E98-B944-E16C54751995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71885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EF2DB39-8DEF-4059-A83A-92ED3144A35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9EA6915-B694-4A57-914D-23737EF5CF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1573E7B-309E-4925-8A55-4E847280C4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37DE-851E-42EB-9DFB-337B07E822DE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C60EB65-2321-4B19-B571-48C9C8FE1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BF5054D-DC2D-4522-B6DD-25655D7B68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62F4D-C8D6-4BD5-9D58-D4C4B09380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50688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7BB429-F153-4056-BE95-DF56A06CEE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24BD1FA-339D-49C9-B964-2AE3CD4713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6D3246C-7FC7-4CA4-99F0-D1DBA0D82C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37DE-851E-42EB-9DFB-337B07E822DE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D2601A-D432-475E-85A3-0C1FA321C7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477CD4A-86DC-46B7-81B9-BB709D5F6F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62F4D-C8D6-4BD5-9D58-D4C4B09380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6254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B5A2EAA-F494-45EF-A405-FF23D97BCC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0F4E468-F694-4326-9DF2-6B2A412D78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D4F3D0-05E5-4B49-956A-1F37CC21FF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37DE-851E-42EB-9DFB-337B07E822DE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ACD5631-1D2D-414F-B8FD-1970CF8AF2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1D1AB2B-6B17-454E-9FB8-4B554464C8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62F4D-C8D6-4BD5-9D58-D4C4B09380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15734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042A6BD-9740-47A2-AEB8-683D7D1C05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D3B2FDA-34A5-4BA7-9F3F-4E04CC4DE2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41B848E-7D7B-4199-8B7A-EFDB1C1AC3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37DE-851E-42EB-9DFB-337B07E822DE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F2538B-F306-4523-99DE-D890454E0C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D5F8369-306B-4720-8EC2-7C2D1D944E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62F4D-C8D6-4BD5-9D58-D4C4B09380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07586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9A888CC-0EA3-4C25-A753-CC5ECE0B16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27CFD40-23FA-4BD2-8EC5-C4C0362FEA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5FFABE6-CA35-4C65-BB03-7E2B27BA0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37DE-851E-42EB-9DFB-337B07E822DE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5C01A34-0599-4659-B302-5C6392B10B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7D5EC40-3E05-4371-A472-217AEFA9D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62F4D-C8D6-4BD5-9D58-D4C4B09380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99918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C98F5D-4AE7-448C-8A42-8A86A080D3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84540C5-A331-4870-8179-C0CECA75F23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D17E048-2DB8-4298-A929-F09C7045E2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676547E-AC94-4D97-B167-2562006C5C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37DE-851E-42EB-9DFB-337B07E822DE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668AE7A-1FAD-46B6-978A-E1910A879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8931A63-0C27-444E-973A-C7BDB9E25D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62F4D-C8D6-4BD5-9D58-D4C4B09380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2142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AA0679-D099-47F2-988F-31E273B55A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422782B-59A2-4DD1-8BCA-79F9C81AD0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BBD944B-EF7A-44B2-A50A-B9717EB95F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A52D4E3-5D87-4921-84B8-A764353CB5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5D65482-57FF-4DBA-B752-08F04D0D42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9779AB9-A758-4CF1-813C-C6F4AE6AFD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37DE-851E-42EB-9DFB-337B07E822DE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0B549F0-52B8-4181-BC86-AFDB39D78C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EF38E4E-1190-4A07-AF27-AFB505DC70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62F4D-C8D6-4BD5-9D58-D4C4B09380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27494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1DEFBD-04C4-4C18-AF8E-821E24FBCB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D6DF456-B415-4929-A06E-5374358D3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37DE-851E-42EB-9DFB-337B07E822DE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0C669E5-8416-4BBC-9594-6FBE12BBDB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5F24F93-7ED2-4FD2-AF1E-2D831BA35F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62F4D-C8D6-4BD5-9D58-D4C4B09380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93222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B3224FE-C1ED-460B-83D6-81C5B9A26A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37DE-851E-42EB-9DFB-337B07E822DE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D7BE639-9E7A-457D-9B89-9037823B3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5ACE947-93E4-45F7-BD71-F83B72D28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62F4D-C8D6-4BD5-9D58-D4C4B09380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28255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4FC6953-7B17-4B08-8BEA-278E5DB0F6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51B44C1-14E4-4F64-AB50-B84A75AD60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31D8B72-CEC4-45A5-97D9-5452510398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8959E7E-2EE0-432D-9741-F26475D2E1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37DE-851E-42EB-9DFB-337B07E822DE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3A3B4DE-312F-491B-81C5-63CDB98F72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F69A0AD-83C0-4FE9-9F07-7448408AF1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62F4D-C8D6-4BD5-9D58-D4C4B09380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9903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34C8030-6A2D-4BB5-97C4-07E863A59A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9E713A8-86E7-459E-B32A-75ADD59A95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25E575C-E33A-45F9-932A-072980BEE2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29932D3-DA9A-4984-B185-E986DE5660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937DE-851E-42EB-9DFB-337B07E822DE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DC7379F-592F-40A2-9D76-F354C1EBA9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BF32BD2-8CD1-47E3-A933-EE89760CBD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62F4D-C8D6-4BD5-9D58-D4C4B09380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850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45D6BC2-7FA4-469A-AAF7-7D7E2FD3AA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9298FA4-41F7-447A-BAF4-0B41DE38F8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7F279BA-A48C-47D0-9D88-97030CBFD3E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2937DE-851E-42EB-9DFB-337B07E822DE}" type="datetimeFigureOut">
              <a:rPr lang="zh-CN" altLang="en-US" smtClean="0"/>
              <a:t>2021/2/2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EBDFAD6-1FD3-447A-B37A-0369046131B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E29C6E5-4BE4-487F-8441-72650CE6E90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162F4D-C8D6-4BD5-9D58-D4C4B09380A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9858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CE05BE23-BE30-4C88-A1B7-34CC14F51A9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76425" y="267726"/>
            <a:ext cx="7996237" cy="5580624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E8EF5CD0-8F2B-4A9D-AC7A-DA6B838DFCB6}"/>
              </a:ext>
            </a:extLst>
          </p:cNvPr>
          <p:cNvSpPr/>
          <p:nvPr/>
        </p:nvSpPr>
        <p:spPr>
          <a:xfrm>
            <a:off x="805343" y="5943943"/>
            <a:ext cx="1077714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Figure S1.</a:t>
            </a:r>
            <a:r>
              <a:rPr lang="en-US" altLang="zh-CN" dirty="0"/>
              <a:t> Partitioned genetic correlation between BF% and HF by genetic variants groups with different P value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041141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830BCF74-80AF-427C-962E-A9E66FD11F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28824" y="75604"/>
            <a:ext cx="8557135" cy="5467945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F2480FCE-9BCA-499A-B7F5-B415FCA5796E}"/>
              </a:ext>
            </a:extLst>
          </p:cNvPr>
          <p:cNvSpPr/>
          <p:nvPr/>
        </p:nvSpPr>
        <p:spPr>
          <a:xfrm>
            <a:off x="609600" y="5667374"/>
            <a:ext cx="10972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Figure S2.</a:t>
            </a:r>
            <a:r>
              <a:rPr lang="en-US" altLang="zh-CN" dirty="0"/>
              <a:t> Partitioned genetic correlation between BF% and CAD by genetic variants groups with different P value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669940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80BC449B-2F85-43AE-A1B1-E0DBF95713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67025" y="584645"/>
            <a:ext cx="5787507" cy="4993973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A5AD129E-F743-4D71-8F2C-D212B433BB38}"/>
              </a:ext>
            </a:extLst>
          </p:cNvPr>
          <p:cNvSpPr/>
          <p:nvPr/>
        </p:nvSpPr>
        <p:spPr>
          <a:xfrm>
            <a:off x="933450" y="6049060"/>
            <a:ext cx="1125855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Figure S3.</a:t>
            </a:r>
            <a:r>
              <a:rPr lang="en-US" altLang="zh-CN" dirty="0"/>
              <a:t> QQ plot of cross-trait meta-analysis between BF% and HF.</a:t>
            </a:r>
            <a:endParaRPr lang="zh-CN" altLang="zh-CN" dirty="0"/>
          </a:p>
        </p:txBody>
      </p:sp>
    </p:spTree>
    <p:extLst>
      <p:ext uri="{BB962C8B-B14F-4D97-AF65-F5344CB8AC3E}">
        <p14:creationId xmlns:p14="http://schemas.microsoft.com/office/powerpoint/2010/main" val="3133935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4791F503-EA7D-4B5E-9FB6-F94B6DC04D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28950" y="661275"/>
            <a:ext cx="5486400" cy="4968000"/>
          </a:xfrm>
          <a:prstGeom prst="rect">
            <a:avLst/>
          </a:prstGeom>
        </p:spPr>
      </p:pic>
      <p:sp>
        <p:nvSpPr>
          <p:cNvPr id="2" name="矩形 1">
            <a:extLst>
              <a:ext uri="{FF2B5EF4-FFF2-40B4-BE49-F238E27FC236}">
                <a16:creationId xmlns:a16="http://schemas.microsoft.com/office/drawing/2014/main" id="{29648776-5F90-4E09-813F-E74FCE804390}"/>
              </a:ext>
            </a:extLst>
          </p:cNvPr>
          <p:cNvSpPr/>
          <p:nvPr/>
        </p:nvSpPr>
        <p:spPr>
          <a:xfrm>
            <a:off x="876300" y="5972175"/>
            <a:ext cx="96393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altLang="zh-CN" b="1" dirty="0"/>
              <a:t>Figure S4.</a:t>
            </a:r>
            <a:r>
              <a:rPr lang="en-US" altLang="zh-CN" dirty="0"/>
              <a:t> QQ plot of cross-trait meta-analysis between BF% and CAD.</a:t>
            </a:r>
            <a:endParaRPr lang="zh-CN" altLang="zh-CN" dirty="0"/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848024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9</TotalTime>
  <Words>144</Words>
  <Application>Microsoft Office PowerPoint</Application>
  <PresentationFormat>宽屏</PresentationFormat>
  <Paragraphs>12</Paragraphs>
  <Slides>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庄 振煌</dc:creator>
  <cp:lastModifiedBy>庄庄</cp:lastModifiedBy>
  <cp:revision>15</cp:revision>
  <dcterms:created xsi:type="dcterms:W3CDTF">2020-05-08T08:24:06Z</dcterms:created>
  <dcterms:modified xsi:type="dcterms:W3CDTF">2021-02-25T11:09:07Z</dcterms:modified>
</cp:coreProperties>
</file>